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94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FCDD4A-787C-41F5-1564-CF19388AB2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BD2DD6C-43B3-5BF2-263C-21D3D7A62E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361C87-AE1B-244D-57EE-98C3FB84B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3D3B30-3C19-4EAD-D649-163558A6B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C3AC9C-AB57-E5AD-B08F-74BBB9DC5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3933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F7E685-150F-3822-AE9F-35C459DF7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79C49F9-2FDE-2C3D-3DA4-493B001D80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E80004-252F-ACAC-743B-E1943996A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4FD2F4-2AE3-EE84-C56D-F23D887EB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733DF3-8757-B2EC-ED8C-BA481A54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6480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2EC5800-B497-5759-8E30-1354C5ADFB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73D33C5-1DDF-D28C-343F-9821D44A90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D33B63-79FA-4A3C-50F6-D8DE97A67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DF0C69-E489-38E3-A0A6-3CA6577188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08B487-AFC6-ABD5-F8D4-7112585E3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833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E0B035-DC4E-027F-2A1C-ECC8EFBBA9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1C798C-2893-BB5C-15FF-537FE45603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0A9161-5548-7AAB-CBB6-F8BDC379A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6BE6CE-C9EA-97DA-E0AE-9A8E81662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E11CEE-D621-F767-28E0-B9B3507AD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5817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4DC9FC-AC3D-58F6-6968-9722F06BA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C7733D-C6F0-5022-0B49-2979DAF080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C41754-DBD6-DEDB-A626-EAFC5EE9C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796DD1-3B27-9EF3-D235-86167EF64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8EBF2A-07E1-D094-9ED3-9CE229BEF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8480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605EFD-DE34-8048-BA7E-56AE50DF78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37DBE27-4A87-4D5D-FA94-D79FD40C44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CD9EA4B-A1F9-C6CC-38E5-5BE6C9694A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33CEF5-F2F0-5D54-8993-04877EC0D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FA9627-2C35-4E1C-28F6-393F444C7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48E9C2-1B73-3958-FADC-E2C9C47A5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072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AFD0CB-48AB-17E1-8136-F487BEDB4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E853BE6-96CB-A312-A1C5-36C38D421A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F980A8-37DF-74B0-CC97-DF8964A25C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0B17F62-9D54-F3FF-EB53-D29F7E5FA2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8EAEC07-F942-E072-865C-4A946D2857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B49C158-AA72-8747-3289-1417D8DB4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22B857E-208D-C2BE-DC95-A0A94ED1A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F408CF8-07B8-1237-EC68-58030399E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763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A7A898-F057-0385-3010-6BF256BE4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A2728FB-9613-55A0-BE62-A5BA504B0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9598CF6-11E8-79F2-1DC5-B3DA63EC9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C1F4D18-1D1A-FCCB-F43A-40861A1C1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8505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710E590-B4BC-D946-69D7-0AF740942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8E33F9B-1774-2040-2FE8-2008D4569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0A44D55-6021-C272-525D-C3DB68B90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650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DC475C-74B5-F223-0AF3-DC1C860B7B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6A8DF8-7205-A43F-C8D5-89A3D39A42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5D52976-1077-344C-2BF4-0BDE8F3A9F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7150FED-C92A-00EF-0725-76570342D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35248D3-83B0-F5C8-9C3E-87F402662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2EA9B0-477D-FA94-E0A3-9D0278F85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4452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75DB44-4EF9-8ECA-3EE9-D3EF15A8FF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3FAD13F-C79F-011D-2D2D-3574CA7F54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3F3B79-89E9-783D-C3DE-A1B8E0B2DE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840789-93F6-C450-F7EB-CA95A1E3C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B43DA6A-FC31-E2A6-532E-C55509210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1D9226A-EC1E-944B-5F81-9B86725CC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55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4243265-FD8C-D1B9-1602-963483BF8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CF98DD-5962-9643-A01C-A8D93B0047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23BD5B-C8D6-A818-1D23-29BCD302BA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A7E8D7-7B66-41DD-BF36-AE4DDCC0161F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35ED9A-07F4-B669-1A5B-C9ECFDF011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426495-6098-3474-88B1-A41B3D59BE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C993B4-41A9-4FE7-A560-5F2F407B31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5526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03663080-B3F1-B176-77ED-0DBC848B4D8A}"/>
              </a:ext>
            </a:extLst>
          </p:cNvPr>
          <p:cNvGrpSpPr/>
          <p:nvPr/>
        </p:nvGrpSpPr>
        <p:grpSpPr>
          <a:xfrm>
            <a:off x="546347" y="677182"/>
            <a:ext cx="10930067" cy="4981767"/>
            <a:chOff x="546347" y="677182"/>
            <a:chExt cx="10930067" cy="4981767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70EE4D80-5D27-9C1A-7C46-AA7C8CA82914}"/>
                </a:ext>
              </a:extLst>
            </p:cNvPr>
            <p:cNvGrpSpPr/>
            <p:nvPr/>
          </p:nvGrpSpPr>
          <p:grpSpPr>
            <a:xfrm>
              <a:off x="546347" y="677182"/>
              <a:ext cx="5140411" cy="2442800"/>
              <a:chOff x="306345" y="-1952159"/>
              <a:chExt cx="5140411" cy="2442800"/>
            </a:xfrm>
          </p:grpSpPr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BC98B82-3771-CF63-5704-7ACC19605FA8}"/>
                  </a:ext>
                </a:extLst>
              </p:cNvPr>
              <p:cNvSpPr txBox="1"/>
              <p:nvPr/>
            </p:nvSpPr>
            <p:spPr>
              <a:xfrm>
                <a:off x="1778514" y="-1952159"/>
                <a:ext cx="17388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ITE-5%</a:t>
                </a:r>
                <a:endParaRPr lang="zh-CN" alt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图片 28" descr="图表, 条形图&#10;&#10;描述已自动生成">
                <a:extLst>
                  <a:ext uri="{FF2B5EF4-FFF2-40B4-BE49-F238E27FC236}">
                    <a16:creationId xmlns:a16="http://schemas.microsoft.com/office/drawing/2014/main" id="{43DDFEA4-30B1-4F81-A6CC-1E2C3618CD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345" y="-1677048"/>
                <a:ext cx="5140411" cy="2167689"/>
              </a:xfrm>
              <a:prstGeom prst="rect">
                <a:avLst/>
              </a:prstGeom>
            </p:spPr>
          </p:pic>
        </p:grpSp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3BCCDE35-1094-FFA9-DF0C-5528031DB145}"/>
                </a:ext>
              </a:extLst>
            </p:cNvPr>
            <p:cNvGrpSpPr/>
            <p:nvPr/>
          </p:nvGrpSpPr>
          <p:grpSpPr>
            <a:xfrm>
              <a:off x="6336002" y="680216"/>
              <a:ext cx="5140412" cy="2439766"/>
              <a:chOff x="306344" y="663362"/>
              <a:chExt cx="5140412" cy="2439766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922F3035-0792-2262-6977-C23D51C865D0}"/>
                  </a:ext>
                </a:extLst>
              </p:cNvPr>
              <p:cNvSpPr txBox="1"/>
              <p:nvPr/>
            </p:nvSpPr>
            <p:spPr>
              <a:xfrm>
                <a:off x="1778514" y="663362"/>
                <a:ext cx="17388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ITE-10%</a:t>
                </a:r>
                <a:endParaRPr lang="zh-CN" alt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7" name="图片 26" descr="图表, 条形图&#10;&#10;描述已自动生成">
                <a:extLst>
                  <a:ext uri="{FF2B5EF4-FFF2-40B4-BE49-F238E27FC236}">
                    <a16:creationId xmlns:a16="http://schemas.microsoft.com/office/drawing/2014/main" id="{2698E2BC-CF8B-261D-BE6E-3635C1DF6B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344" y="935438"/>
                <a:ext cx="5140412" cy="2167690"/>
              </a:xfrm>
              <a:prstGeom prst="rect">
                <a:avLst/>
              </a:prstGeom>
            </p:spPr>
          </p:pic>
        </p:grp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5A4FD0C2-1695-3818-B1AE-6EAD4F6B24FD}"/>
                </a:ext>
              </a:extLst>
            </p:cNvPr>
            <p:cNvGrpSpPr/>
            <p:nvPr/>
          </p:nvGrpSpPr>
          <p:grpSpPr>
            <a:xfrm>
              <a:off x="546347" y="3221582"/>
              <a:ext cx="5146378" cy="2437367"/>
              <a:chOff x="306344" y="3262770"/>
              <a:chExt cx="5146378" cy="2437367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9C06E186-4DE5-D89E-DCCF-20972F50053E}"/>
                  </a:ext>
                </a:extLst>
              </p:cNvPr>
              <p:cNvSpPr txBox="1"/>
              <p:nvPr/>
            </p:nvSpPr>
            <p:spPr>
              <a:xfrm>
                <a:off x="1778514" y="3262770"/>
                <a:ext cx="190489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ltiome-5%</a:t>
                </a:r>
                <a:endParaRPr lang="zh-CN" alt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5" name="图片 24" descr="图表, 条形图&#10;&#10;描述已自动生成">
                <a:extLst>
                  <a:ext uri="{FF2B5EF4-FFF2-40B4-BE49-F238E27FC236}">
                    <a16:creationId xmlns:a16="http://schemas.microsoft.com/office/drawing/2014/main" id="{58F96574-9C69-D476-8674-665206B93A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344" y="3532447"/>
                <a:ext cx="5146378" cy="2167690"/>
              </a:xfrm>
              <a:prstGeom prst="rect">
                <a:avLst/>
              </a:prstGeom>
            </p:spPr>
          </p:pic>
        </p:grp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5F2F2831-FACB-C0EB-3086-87BA4C9409B6}"/>
                </a:ext>
              </a:extLst>
            </p:cNvPr>
            <p:cNvGrpSpPr/>
            <p:nvPr/>
          </p:nvGrpSpPr>
          <p:grpSpPr>
            <a:xfrm>
              <a:off x="6336002" y="3218011"/>
              <a:ext cx="5140411" cy="2440938"/>
              <a:chOff x="278885" y="5849857"/>
              <a:chExt cx="5140411" cy="2440938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E93C42F8-8CAC-31EF-2E7C-1FC348B33BA6}"/>
                  </a:ext>
                </a:extLst>
              </p:cNvPr>
              <p:cNvSpPr txBox="1"/>
              <p:nvPr/>
            </p:nvSpPr>
            <p:spPr>
              <a:xfrm>
                <a:off x="1861527" y="5849857"/>
                <a:ext cx="17388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ltiome-10%</a:t>
                </a:r>
                <a:endParaRPr lang="zh-CN" altLang="en-US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3" name="图片 22" descr="图表, 条形图&#10;&#10;描述已自动生成">
                <a:extLst>
                  <a:ext uri="{FF2B5EF4-FFF2-40B4-BE49-F238E27FC236}">
                    <a16:creationId xmlns:a16="http://schemas.microsoft.com/office/drawing/2014/main" id="{9DC02618-02A6-E7D4-790D-9EDE705E43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8885" y="6123106"/>
                <a:ext cx="5140411" cy="2167689"/>
              </a:xfrm>
              <a:prstGeom prst="rect">
                <a:avLst/>
              </a:prstGeom>
            </p:spPr>
          </p:pic>
        </p:grp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B45D99F4-8D2A-101F-C727-E724851CEA3D}"/>
              </a:ext>
            </a:extLst>
          </p:cNvPr>
          <p:cNvGrpSpPr/>
          <p:nvPr/>
        </p:nvGrpSpPr>
        <p:grpSpPr>
          <a:xfrm>
            <a:off x="4907280" y="1553661"/>
            <a:ext cx="815340" cy="860425"/>
            <a:chOff x="4907280" y="1553661"/>
            <a:chExt cx="815340" cy="860425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66DAAF5E-3A93-20BC-1B6A-B7B12E6832C4}"/>
                </a:ext>
              </a:extLst>
            </p:cNvPr>
            <p:cNvGrpSpPr/>
            <p:nvPr/>
          </p:nvGrpSpPr>
          <p:grpSpPr>
            <a:xfrm>
              <a:off x="4907280" y="1553661"/>
              <a:ext cx="779478" cy="169277"/>
              <a:chOff x="4907280" y="1553661"/>
              <a:chExt cx="779478" cy="169277"/>
            </a:xfrm>
          </p:grpSpPr>
          <p:sp>
            <p:nvSpPr>
              <p:cNvPr id="2" name="矩形 1">
                <a:extLst>
                  <a:ext uri="{FF2B5EF4-FFF2-40B4-BE49-F238E27FC236}">
                    <a16:creationId xmlns:a16="http://schemas.microsoft.com/office/drawing/2014/main" id="{2B44878B-6BCE-4CB0-33C5-BBABA69C545F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732C3B05-252B-2AB1-867F-7D7668D51FC6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DAB8C4F7-6930-8BD8-2CB8-851F816D7695}"/>
                </a:ext>
              </a:extLst>
            </p:cNvPr>
            <p:cNvGrpSpPr/>
            <p:nvPr/>
          </p:nvGrpSpPr>
          <p:grpSpPr>
            <a:xfrm>
              <a:off x="4907280" y="1654661"/>
              <a:ext cx="815340" cy="169277"/>
              <a:chOff x="4907280" y="1553661"/>
              <a:chExt cx="815340" cy="169277"/>
            </a:xfrm>
          </p:grpSpPr>
          <p:sp>
            <p:nvSpPr>
              <p:cNvPr id="6" name="矩形 5">
                <a:extLst>
                  <a:ext uri="{FF2B5EF4-FFF2-40B4-BE49-F238E27FC236}">
                    <a16:creationId xmlns:a16="http://schemas.microsoft.com/office/drawing/2014/main" id="{03BFF8DE-CFD6-68D9-7D23-4CCEE1465F1F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AF5FB4E7-EF7E-3E1D-12B3-034290779F78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FBECAD64-A763-441A-F6DA-A8347AFA324D}"/>
                </a:ext>
              </a:extLst>
            </p:cNvPr>
            <p:cNvGrpSpPr/>
            <p:nvPr/>
          </p:nvGrpSpPr>
          <p:grpSpPr>
            <a:xfrm>
              <a:off x="4907280" y="1757898"/>
              <a:ext cx="815340" cy="169277"/>
              <a:chOff x="4907280" y="1553661"/>
              <a:chExt cx="815340" cy="169277"/>
            </a:xfrm>
          </p:grpSpPr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F85A4A0E-EA45-50F0-4160-B6688C0FAF5A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2B44461C-4B7E-FF1B-8504-91A69F7BCF47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90184A45-B31D-BD0B-4918-B8A4F4B771BA}"/>
                </a:ext>
              </a:extLst>
            </p:cNvPr>
            <p:cNvGrpSpPr/>
            <p:nvPr/>
          </p:nvGrpSpPr>
          <p:grpSpPr>
            <a:xfrm>
              <a:off x="4907280" y="1847391"/>
              <a:ext cx="815340" cy="169277"/>
              <a:chOff x="4907280" y="1544136"/>
              <a:chExt cx="815340" cy="169277"/>
            </a:xfrm>
          </p:grpSpPr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834CCB8E-7C1D-6B12-D075-7523F5F75BA5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7A46942F-BF83-0154-FC83-E7E00A5ADBC6}"/>
                  </a:ext>
                </a:extLst>
              </p:cNvPr>
              <p:cNvSpPr txBox="1"/>
              <p:nvPr/>
            </p:nvSpPr>
            <p:spPr>
              <a:xfrm>
                <a:off x="4907280" y="1544136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10F8C282-8C2A-93EC-D3C4-BFB0059BCC51}"/>
                </a:ext>
              </a:extLst>
            </p:cNvPr>
            <p:cNvGrpSpPr/>
            <p:nvPr/>
          </p:nvGrpSpPr>
          <p:grpSpPr>
            <a:xfrm>
              <a:off x="4907280" y="1941554"/>
              <a:ext cx="779478" cy="169277"/>
              <a:chOff x="4907280" y="1553661"/>
              <a:chExt cx="779478" cy="169277"/>
            </a:xfrm>
          </p:grpSpPr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617E75AB-4AB4-4935-CDEB-2271A7BCA242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34928A26-F456-6F35-A8C8-412D222510E1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EEF0AF10-9D9B-F09C-7988-958BEF1D27FD}"/>
                </a:ext>
              </a:extLst>
            </p:cNvPr>
            <p:cNvGrpSpPr/>
            <p:nvPr/>
          </p:nvGrpSpPr>
          <p:grpSpPr>
            <a:xfrm>
              <a:off x="4907280" y="2042554"/>
              <a:ext cx="815340" cy="169277"/>
              <a:chOff x="4907280" y="1553661"/>
              <a:chExt cx="815340" cy="169277"/>
            </a:xfrm>
          </p:grpSpPr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F5B78733-2E03-81FD-2DB2-8B8B30772BC0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5F081ED6-E789-8CF7-7D2D-CB14F6985CFF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28E8C388-D79D-FBC1-791E-60778CCFC335}"/>
                </a:ext>
              </a:extLst>
            </p:cNvPr>
            <p:cNvGrpSpPr/>
            <p:nvPr/>
          </p:nvGrpSpPr>
          <p:grpSpPr>
            <a:xfrm>
              <a:off x="4907280" y="2145791"/>
              <a:ext cx="815340" cy="169277"/>
              <a:chOff x="4907280" y="1553661"/>
              <a:chExt cx="815340" cy="169277"/>
            </a:xfrm>
          </p:grpSpPr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CF0331B7-EF84-61CA-8E93-0E1ABF73610E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532E1B28-C1E7-3B02-94D6-EA21B7BAA826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CDD16E71-EFA4-7330-8820-15928A40737B}"/>
                </a:ext>
              </a:extLst>
            </p:cNvPr>
            <p:cNvGrpSpPr/>
            <p:nvPr/>
          </p:nvGrpSpPr>
          <p:grpSpPr>
            <a:xfrm>
              <a:off x="4907280" y="2244809"/>
              <a:ext cx="815340" cy="169277"/>
              <a:chOff x="4907280" y="1553661"/>
              <a:chExt cx="815340" cy="169277"/>
            </a:xfrm>
          </p:grpSpPr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F5BCFD4A-71DE-BDF1-9AE2-43C540B98708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938C9B78-20D3-D8F3-5DB5-7B3AC24998FE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59A363F7-E448-1561-97BB-D6B1A4F29653}"/>
              </a:ext>
            </a:extLst>
          </p:cNvPr>
          <p:cNvGrpSpPr/>
          <p:nvPr/>
        </p:nvGrpSpPr>
        <p:grpSpPr>
          <a:xfrm>
            <a:off x="10688320" y="1552158"/>
            <a:ext cx="815340" cy="860425"/>
            <a:chOff x="4907280" y="1553661"/>
            <a:chExt cx="815340" cy="860425"/>
          </a:xfrm>
        </p:grpSpPr>
        <p:grpSp>
          <p:nvGrpSpPr>
            <p:cNvPr id="69" name="组合 68">
              <a:extLst>
                <a:ext uri="{FF2B5EF4-FFF2-40B4-BE49-F238E27FC236}">
                  <a16:creationId xmlns:a16="http://schemas.microsoft.com/office/drawing/2014/main" id="{4A54FAA0-BB26-7CA0-A925-887D012AAE0D}"/>
                </a:ext>
              </a:extLst>
            </p:cNvPr>
            <p:cNvGrpSpPr/>
            <p:nvPr/>
          </p:nvGrpSpPr>
          <p:grpSpPr>
            <a:xfrm>
              <a:off x="4907280" y="1553661"/>
              <a:ext cx="779478" cy="169277"/>
              <a:chOff x="4907280" y="1553661"/>
              <a:chExt cx="779478" cy="169277"/>
            </a:xfrm>
          </p:grpSpPr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9AE251B3-3CDC-CFAD-FEB5-5B0952E89F38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7D98EDB0-0033-D313-9443-0D30C49E0D25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14C0CCB8-311D-BB58-48E4-40DA0E80728E}"/>
                </a:ext>
              </a:extLst>
            </p:cNvPr>
            <p:cNvGrpSpPr/>
            <p:nvPr/>
          </p:nvGrpSpPr>
          <p:grpSpPr>
            <a:xfrm>
              <a:off x="4907280" y="1654661"/>
              <a:ext cx="815340" cy="169277"/>
              <a:chOff x="4907280" y="1553661"/>
              <a:chExt cx="815340" cy="169277"/>
            </a:xfrm>
          </p:grpSpPr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id="{CB738218-565E-7B08-49A0-003C2D744FB3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7D96A5C5-627E-4ABA-2D6C-C545E279DFDA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05E0E5F8-EF1D-1952-EB44-0C534C34C5A6}"/>
                </a:ext>
              </a:extLst>
            </p:cNvPr>
            <p:cNvGrpSpPr/>
            <p:nvPr/>
          </p:nvGrpSpPr>
          <p:grpSpPr>
            <a:xfrm>
              <a:off x="4907280" y="1757898"/>
              <a:ext cx="815340" cy="169277"/>
              <a:chOff x="4907280" y="1553661"/>
              <a:chExt cx="815340" cy="169277"/>
            </a:xfrm>
          </p:grpSpPr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DC2D00F2-1C55-E404-51BE-4254EF214C4C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66B7B5B2-5C51-D0F5-7E09-F19906DD8AA5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827F36C5-7263-25ED-5240-A8A87D69C610}"/>
                </a:ext>
              </a:extLst>
            </p:cNvPr>
            <p:cNvGrpSpPr/>
            <p:nvPr/>
          </p:nvGrpSpPr>
          <p:grpSpPr>
            <a:xfrm>
              <a:off x="4907280" y="1847391"/>
              <a:ext cx="815340" cy="169277"/>
              <a:chOff x="4907280" y="1544136"/>
              <a:chExt cx="815340" cy="169277"/>
            </a:xfrm>
          </p:grpSpPr>
          <p:sp>
            <p:nvSpPr>
              <p:cNvPr id="85" name="矩形 84">
                <a:extLst>
                  <a:ext uri="{FF2B5EF4-FFF2-40B4-BE49-F238E27FC236}">
                    <a16:creationId xmlns:a16="http://schemas.microsoft.com/office/drawing/2014/main" id="{33E98938-BDAE-DE4A-DD40-41956C18CE81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D71C6DA5-B852-FE2D-E113-6E6A55AE4C1A}"/>
                  </a:ext>
                </a:extLst>
              </p:cNvPr>
              <p:cNvSpPr txBox="1"/>
              <p:nvPr/>
            </p:nvSpPr>
            <p:spPr>
              <a:xfrm>
                <a:off x="4907280" y="1544136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E7EDF87F-1D2E-522C-3605-6E158D15586C}"/>
                </a:ext>
              </a:extLst>
            </p:cNvPr>
            <p:cNvGrpSpPr/>
            <p:nvPr/>
          </p:nvGrpSpPr>
          <p:grpSpPr>
            <a:xfrm>
              <a:off x="4907280" y="1941554"/>
              <a:ext cx="779478" cy="169277"/>
              <a:chOff x="4907280" y="1553661"/>
              <a:chExt cx="779478" cy="169277"/>
            </a:xfrm>
          </p:grpSpPr>
          <p:sp>
            <p:nvSpPr>
              <p:cNvPr id="83" name="矩形 82">
                <a:extLst>
                  <a:ext uri="{FF2B5EF4-FFF2-40B4-BE49-F238E27FC236}">
                    <a16:creationId xmlns:a16="http://schemas.microsoft.com/office/drawing/2014/main" id="{02290DB1-B92F-7222-B778-15F9B123BE61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1431BDA5-6480-04BE-1056-8731B7A4AEA1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EE40BBA2-D0D3-7851-25CE-803F11AC3B05}"/>
                </a:ext>
              </a:extLst>
            </p:cNvPr>
            <p:cNvGrpSpPr/>
            <p:nvPr/>
          </p:nvGrpSpPr>
          <p:grpSpPr>
            <a:xfrm>
              <a:off x="4907280" y="2042554"/>
              <a:ext cx="815340" cy="169277"/>
              <a:chOff x="4907280" y="1553661"/>
              <a:chExt cx="815340" cy="169277"/>
            </a:xfrm>
          </p:grpSpPr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AEE1B924-EFB6-41D6-1A8E-FB07B6D593C3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E3202A74-3440-3A5B-CF6D-D06A0A0518A5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C321FA91-29B8-BD32-0BEF-18D267C38E35}"/>
                </a:ext>
              </a:extLst>
            </p:cNvPr>
            <p:cNvGrpSpPr/>
            <p:nvPr/>
          </p:nvGrpSpPr>
          <p:grpSpPr>
            <a:xfrm>
              <a:off x="4907280" y="2145791"/>
              <a:ext cx="815340" cy="169277"/>
              <a:chOff x="4907280" y="1553661"/>
              <a:chExt cx="815340" cy="169277"/>
            </a:xfrm>
          </p:grpSpPr>
          <p:sp>
            <p:nvSpPr>
              <p:cNvPr id="79" name="矩形 78">
                <a:extLst>
                  <a:ext uri="{FF2B5EF4-FFF2-40B4-BE49-F238E27FC236}">
                    <a16:creationId xmlns:a16="http://schemas.microsoft.com/office/drawing/2014/main" id="{A2301067-56E5-B9CD-E503-A3DCA7D8E411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5E8015AC-BB13-CE3F-6C53-F690F9E88D8D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id="{02F335F4-36E4-08D0-95D7-C6119605275D}"/>
                </a:ext>
              </a:extLst>
            </p:cNvPr>
            <p:cNvGrpSpPr/>
            <p:nvPr/>
          </p:nvGrpSpPr>
          <p:grpSpPr>
            <a:xfrm>
              <a:off x="4907280" y="2244809"/>
              <a:ext cx="815340" cy="169277"/>
              <a:chOff x="4907280" y="1553661"/>
              <a:chExt cx="815340" cy="169277"/>
            </a:xfrm>
          </p:grpSpPr>
          <p:sp>
            <p:nvSpPr>
              <p:cNvPr id="77" name="矩形 76">
                <a:extLst>
                  <a:ext uri="{FF2B5EF4-FFF2-40B4-BE49-F238E27FC236}">
                    <a16:creationId xmlns:a16="http://schemas.microsoft.com/office/drawing/2014/main" id="{9FEEB236-7310-7666-77E4-CD949875C6F3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64EE553B-5C48-EEC3-0EC6-E011292C0DBF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CBD1F52B-4872-0684-6344-7A142BDDF637}"/>
              </a:ext>
            </a:extLst>
          </p:cNvPr>
          <p:cNvGrpSpPr/>
          <p:nvPr/>
        </p:nvGrpSpPr>
        <p:grpSpPr>
          <a:xfrm>
            <a:off x="10686899" y="4092158"/>
            <a:ext cx="815340" cy="860425"/>
            <a:chOff x="4907280" y="1553661"/>
            <a:chExt cx="815340" cy="860425"/>
          </a:xfrm>
        </p:grpSpPr>
        <p:grpSp>
          <p:nvGrpSpPr>
            <p:cNvPr id="94" name="组合 93">
              <a:extLst>
                <a:ext uri="{FF2B5EF4-FFF2-40B4-BE49-F238E27FC236}">
                  <a16:creationId xmlns:a16="http://schemas.microsoft.com/office/drawing/2014/main" id="{0DB5FF8A-EFB3-0FB2-201A-72184137021D}"/>
                </a:ext>
              </a:extLst>
            </p:cNvPr>
            <p:cNvGrpSpPr/>
            <p:nvPr/>
          </p:nvGrpSpPr>
          <p:grpSpPr>
            <a:xfrm>
              <a:off x="4907280" y="1553661"/>
              <a:ext cx="779478" cy="169277"/>
              <a:chOff x="4907280" y="1553661"/>
              <a:chExt cx="779478" cy="169277"/>
            </a:xfrm>
          </p:grpSpPr>
          <p:sp>
            <p:nvSpPr>
              <p:cNvPr id="116" name="矩形 115">
                <a:extLst>
                  <a:ext uri="{FF2B5EF4-FFF2-40B4-BE49-F238E27FC236}">
                    <a16:creationId xmlns:a16="http://schemas.microsoft.com/office/drawing/2014/main" id="{1603AB5D-52B3-9785-7AA6-838155B1CED4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4D97BAA8-9DB7-14D4-37ED-003F2E2BF5B7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5" name="组合 94">
              <a:extLst>
                <a:ext uri="{FF2B5EF4-FFF2-40B4-BE49-F238E27FC236}">
                  <a16:creationId xmlns:a16="http://schemas.microsoft.com/office/drawing/2014/main" id="{7C80C2FE-19EB-1A92-4A27-93A9BE4D9FD2}"/>
                </a:ext>
              </a:extLst>
            </p:cNvPr>
            <p:cNvGrpSpPr/>
            <p:nvPr/>
          </p:nvGrpSpPr>
          <p:grpSpPr>
            <a:xfrm>
              <a:off x="4907280" y="1654661"/>
              <a:ext cx="815340" cy="169277"/>
              <a:chOff x="4907280" y="1553661"/>
              <a:chExt cx="815340" cy="169277"/>
            </a:xfrm>
          </p:grpSpPr>
          <p:sp>
            <p:nvSpPr>
              <p:cNvPr id="114" name="矩形 113">
                <a:extLst>
                  <a:ext uri="{FF2B5EF4-FFF2-40B4-BE49-F238E27FC236}">
                    <a16:creationId xmlns:a16="http://schemas.microsoft.com/office/drawing/2014/main" id="{924C19D4-BC04-FB41-F750-9CB774A27518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6EC3799F-9210-E73F-F7E1-4A65F5D2BEFB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6" name="组合 95">
              <a:extLst>
                <a:ext uri="{FF2B5EF4-FFF2-40B4-BE49-F238E27FC236}">
                  <a16:creationId xmlns:a16="http://schemas.microsoft.com/office/drawing/2014/main" id="{CFFCE558-8657-E776-E13E-6DB2C0445118}"/>
                </a:ext>
              </a:extLst>
            </p:cNvPr>
            <p:cNvGrpSpPr/>
            <p:nvPr/>
          </p:nvGrpSpPr>
          <p:grpSpPr>
            <a:xfrm>
              <a:off x="4907280" y="1757898"/>
              <a:ext cx="815340" cy="169277"/>
              <a:chOff x="4907280" y="1553661"/>
              <a:chExt cx="815340" cy="169277"/>
            </a:xfrm>
          </p:grpSpPr>
          <p:sp>
            <p:nvSpPr>
              <p:cNvPr id="112" name="矩形 111">
                <a:extLst>
                  <a:ext uri="{FF2B5EF4-FFF2-40B4-BE49-F238E27FC236}">
                    <a16:creationId xmlns:a16="http://schemas.microsoft.com/office/drawing/2014/main" id="{8116855C-4235-E4C9-E3B0-241B3737A5F5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81F4D28F-C15C-1C1F-FE5F-EF4FD6694DE3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7" name="组合 96">
              <a:extLst>
                <a:ext uri="{FF2B5EF4-FFF2-40B4-BE49-F238E27FC236}">
                  <a16:creationId xmlns:a16="http://schemas.microsoft.com/office/drawing/2014/main" id="{A4CD38F9-FE2D-7739-AE5A-4574892235E6}"/>
                </a:ext>
              </a:extLst>
            </p:cNvPr>
            <p:cNvGrpSpPr/>
            <p:nvPr/>
          </p:nvGrpSpPr>
          <p:grpSpPr>
            <a:xfrm>
              <a:off x="4907280" y="1847391"/>
              <a:ext cx="815340" cy="169277"/>
              <a:chOff x="4907280" y="1544136"/>
              <a:chExt cx="815340" cy="169277"/>
            </a:xfrm>
          </p:grpSpPr>
          <p:sp>
            <p:nvSpPr>
              <p:cNvPr id="110" name="矩形 109">
                <a:extLst>
                  <a:ext uri="{FF2B5EF4-FFF2-40B4-BE49-F238E27FC236}">
                    <a16:creationId xmlns:a16="http://schemas.microsoft.com/office/drawing/2014/main" id="{3D355AE7-1E10-32E6-0E98-B44CD0C9EDC7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4BDCA903-53D9-5C82-BD5C-E02D2AFE5C7A}"/>
                  </a:ext>
                </a:extLst>
              </p:cNvPr>
              <p:cNvSpPr txBox="1"/>
              <p:nvPr/>
            </p:nvSpPr>
            <p:spPr>
              <a:xfrm>
                <a:off x="4907280" y="1544136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8" name="组合 97">
              <a:extLst>
                <a:ext uri="{FF2B5EF4-FFF2-40B4-BE49-F238E27FC236}">
                  <a16:creationId xmlns:a16="http://schemas.microsoft.com/office/drawing/2014/main" id="{05019176-1E9D-7A53-47FF-C1BDCA416897}"/>
                </a:ext>
              </a:extLst>
            </p:cNvPr>
            <p:cNvGrpSpPr/>
            <p:nvPr/>
          </p:nvGrpSpPr>
          <p:grpSpPr>
            <a:xfrm>
              <a:off x="4907280" y="1941554"/>
              <a:ext cx="779478" cy="169277"/>
              <a:chOff x="4907280" y="1553661"/>
              <a:chExt cx="779478" cy="169277"/>
            </a:xfrm>
          </p:grpSpPr>
          <p:sp>
            <p:nvSpPr>
              <p:cNvPr id="108" name="矩形 107">
                <a:extLst>
                  <a:ext uri="{FF2B5EF4-FFF2-40B4-BE49-F238E27FC236}">
                    <a16:creationId xmlns:a16="http://schemas.microsoft.com/office/drawing/2014/main" id="{28BBFDC5-AA23-E571-97AD-B24EF9CAB379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23C8366D-878B-4F83-E26C-EC917675B125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9" name="组合 98">
              <a:extLst>
                <a:ext uri="{FF2B5EF4-FFF2-40B4-BE49-F238E27FC236}">
                  <a16:creationId xmlns:a16="http://schemas.microsoft.com/office/drawing/2014/main" id="{675987EB-1412-915A-102B-A1CEB9F0DB4C}"/>
                </a:ext>
              </a:extLst>
            </p:cNvPr>
            <p:cNvGrpSpPr/>
            <p:nvPr/>
          </p:nvGrpSpPr>
          <p:grpSpPr>
            <a:xfrm>
              <a:off x="4907280" y="2042554"/>
              <a:ext cx="815340" cy="169277"/>
              <a:chOff x="4907280" y="1553661"/>
              <a:chExt cx="815340" cy="169277"/>
            </a:xfrm>
          </p:grpSpPr>
          <p:sp>
            <p:nvSpPr>
              <p:cNvPr id="106" name="矩形 105">
                <a:extLst>
                  <a:ext uri="{FF2B5EF4-FFF2-40B4-BE49-F238E27FC236}">
                    <a16:creationId xmlns:a16="http://schemas.microsoft.com/office/drawing/2014/main" id="{3B446E91-04B5-74AD-14B9-C2AAA567649E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7D145186-4BF0-253D-F350-1061C87EED0A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0" name="组合 99">
              <a:extLst>
                <a:ext uri="{FF2B5EF4-FFF2-40B4-BE49-F238E27FC236}">
                  <a16:creationId xmlns:a16="http://schemas.microsoft.com/office/drawing/2014/main" id="{22EC5EE6-ABEC-EC3C-5D1C-B9FD38AE8157}"/>
                </a:ext>
              </a:extLst>
            </p:cNvPr>
            <p:cNvGrpSpPr/>
            <p:nvPr/>
          </p:nvGrpSpPr>
          <p:grpSpPr>
            <a:xfrm>
              <a:off x="4907280" y="2145791"/>
              <a:ext cx="815340" cy="169277"/>
              <a:chOff x="4907280" y="1553661"/>
              <a:chExt cx="815340" cy="169277"/>
            </a:xfrm>
          </p:grpSpPr>
          <p:sp>
            <p:nvSpPr>
              <p:cNvPr id="104" name="矩形 103">
                <a:extLst>
                  <a:ext uri="{FF2B5EF4-FFF2-40B4-BE49-F238E27FC236}">
                    <a16:creationId xmlns:a16="http://schemas.microsoft.com/office/drawing/2014/main" id="{3DA6C96F-05DA-892A-BF43-4EA5BF4752F6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535035A7-477D-3373-40D3-8B59BD2F1006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1" name="组合 100">
              <a:extLst>
                <a:ext uri="{FF2B5EF4-FFF2-40B4-BE49-F238E27FC236}">
                  <a16:creationId xmlns:a16="http://schemas.microsoft.com/office/drawing/2014/main" id="{1C286DC4-739E-E0E8-F0DC-218CF4C76FAD}"/>
                </a:ext>
              </a:extLst>
            </p:cNvPr>
            <p:cNvGrpSpPr/>
            <p:nvPr/>
          </p:nvGrpSpPr>
          <p:grpSpPr>
            <a:xfrm>
              <a:off x="4907280" y="2244809"/>
              <a:ext cx="815340" cy="169277"/>
              <a:chOff x="4907280" y="1553661"/>
              <a:chExt cx="815340" cy="169277"/>
            </a:xfrm>
          </p:grpSpPr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EBC74427-82FE-9D3E-7179-7CD6AC6079F3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CADFF9B6-9910-6ABC-1235-8AF6D2B2B14E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18" name="组合 117">
            <a:extLst>
              <a:ext uri="{FF2B5EF4-FFF2-40B4-BE49-F238E27FC236}">
                <a16:creationId xmlns:a16="http://schemas.microsoft.com/office/drawing/2014/main" id="{CAC09D54-8B36-4461-766C-0FED6376C8B2}"/>
              </a:ext>
            </a:extLst>
          </p:cNvPr>
          <p:cNvGrpSpPr/>
          <p:nvPr/>
        </p:nvGrpSpPr>
        <p:grpSpPr>
          <a:xfrm>
            <a:off x="4890298" y="4087606"/>
            <a:ext cx="815340" cy="860425"/>
            <a:chOff x="4907280" y="1553661"/>
            <a:chExt cx="815340" cy="860425"/>
          </a:xfrm>
        </p:grpSpPr>
        <p:grpSp>
          <p:nvGrpSpPr>
            <p:cNvPr id="119" name="组合 118">
              <a:extLst>
                <a:ext uri="{FF2B5EF4-FFF2-40B4-BE49-F238E27FC236}">
                  <a16:creationId xmlns:a16="http://schemas.microsoft.com/office/drawing/2014/main" id="{F2791140-F6DE-1B6E-1A92-D480510D2EA1}"/>
                </a:ext>
              </a:extLst>
            </p:cNvPr>
            <p:cNvGrpSpPr/>
            <p:nvPr/>
          </p:nvGrpSpPr>
          <p:grpSpPr>
            <a:xfrm>
              <a:off x="4907280" y="1553661"/>
              <a:ext cx="779478" cy="169277"/>
              <a:chOff x="4907280" y="1553661"/>
              <a:chExt cx="779478" cy="169277"/>
            </a:xfrm>
          </p:grpSpPr>
          <p:sp>
            <p:nvSpPr>
              <p:cNvPr id="141" name="矩形 140">
                <a:extLst>
                  <a:ext uri="{FF2B5EF4-FFF2-40B4-BE49-F238E27FC236}">
                    <a16:creationId xmlns:a16="http://schemas.microsoft.com/office/drawing/2014/main" id="{CBFB831C-274A-C066-20DF-DC98B1AD546D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51F23CBF-D829-1B52-DA05-D681FAC9BAF7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0" name="组合 119">
              <a:extLst>
                <a:ext uri="{FF2B5EF4-FFF2-40B4-BE49-F238E27FC236}">
                  <a16:creationId xmlns:a16="http://schemas.microsoft.com/office/drawing/2014/main" id="{DD6A571F-D0B9-9B24-5B58-4D90ADADA524}"/>
                </a:ext>
              </a:extLst>
            </p:cNvPr>
            <p:cNvGrpSpPr/>
            <p:nvPr/>
          </p:nvGrpSpPr>
          <p:grpSpPr>
            <a:xfrm>
              <a:off x="4907280" y="1654661"/>
              <a:ext cx="815340" cy="169277"/>
              <a:chOff x="4907280" y="1553661"/>
              <a:chExt cx="815340" cy="169277"/>
            </a:xfrm>
          </p:grpSpPr>
          <p:sp>
            <p:nvSpPr>
              <p:cNvPr id="139" name="矩形 138">
                <a:extLst>
                  <a:ext uri="{FF2B5EF4-FFF2-40B4-BE49-F238E27FC236}">
                    <a16:creationId xmlns:a16="http://schemas.microsoft.com/office/drawing/2014/main" id="{EB882D41-F9DE-2BB6-851C-33B92F64F829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164CDB20-4F6F-F275-9C8D-18F40E4D4F36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F53EE040-40D3-2DDC-1BA7-E527F08E4F2F}"/>
                </a:ext>
              </a:extLst>
            </p:cNvPr>
            <p:cNvGrpSpPr/>
            <p:nvPr/>
          </p:nvGrpSpPr>
          <p:grpSpPr>
            <a:xfrm>
              <a:off x="4907280" y="1757898"/>
              <a:ext cx="815340" cy="169277"/>
              <a:chOff x="4907280" y="1553661"/>
              <a:chExt cx="815340" cy="169277"/>
            </a:xfrm>
          </p:grpSpPr>
          <p:sp>
            <p:nvSpPr>
              <p:cNvPr id="137" name="矩形 136">
                <a:extLst>
                  <a:ext uri="{FF2B5EF4-FFF2-40B4-BE49-F238E27FC236}">
                    <a16:creationId xmlns:a16="http://schemas.microsoft.com/office/drawing/2014/main" id="{EDC546F9-5594-F5ED-99EA-32CF87DBF38D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3085ED2C-F957-AA4C-AB21-BC77C9225851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2" name="组合 121">
              <a:extLst>
                <a:ext uri="{FF2B5EF4-FFF2-40B4-BE49-F238E27FC236}">
                  <a16:creationId xmlns:a16="http://schemas.microsoft.com/office/drawing/2014/main" id="{00791425-09D4-A4D4-7D57-A0B4ECDC42F6}"/>
                </a:ext>
              </a:extLst>
            </p:cNvPr>
            <p:cNvGrpSpPr/>
            <p:nvPr/>
          </p:nvGrpSpPr>
          <p:grpSpPr>
            <a:xfrm>
              <a:off x="4907280" y="1847391"/>
              <a:ext cx="815340" cy="169277"/>
              <a:chOff x="4907280" y="1544136"/>
              <a:chExt cx="815340" cy="169277"/>
            </a:xfrm>
          </p:grpSpPr>
          <p:sp>
            <p:nvSpPr>
              <p:cNvPr id="135" name="矩形 134">
                <a:extLst>
                  <a:ext uri="{FF2B5EF4-FFF2-40B4-BE49-F238E27FC236}">
                    <a16:creationId xmlns:a16="http://schemas.microsoft.com/office/drawing/2014/main" id="{36810EA7-17C4-75F6-F017-DC16C66B57ED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D16337F9-64B9-411B-6A07-D4550F599062}"/>
                  </a:ext>
                </a:extLst>
              </p:cNvPr>
              <p:cNvSpPr txBox="1"/>
              <p:nvPr/>
            </p:nvSpPr>
            <p:spPr>
              <a:xfrm>
                <a:off x="4907280" y="1544136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3" name="组合 122">
              <a:extLst>
                <a:ext uri="{FF2B5EF4-FFF2-40B4-BE49-F238E27FC236}">
                  <a16:creationId xmlns:a16="http://schemas.microsoft.com/office/drawing/2014/main" id="{13ED3BF5-D6FA-F63E-A793-FF007D8FCF52}"/>
                </a:ext>
              </a:extLst>
            </p:cNvPr>
            <p:cNvGrpSpPr/>
            <p:nvPr/>
          </p:nvGrpSpPr>
          <p:grpSpPr>
            <a:xfrm>
              <a:off x="4907280" y="1941554"/>
              <a:ext cx="779478" cy="169277"/>
              <a:chOff x="4907280" y="1553661"/>
              <a:chExt cx="779478" cy="169277"/>
            </a:xfrm>
          </p:grpSpPr>
          <p:sp>
            <p:nvSpPr>
              <p:cNvPr id="133" name="矩形 132">
                <a:extLst>
                  <a:ext uri="{FF2B5EF4-FFF2-40B4-BE49-F238E27FC236}">
                    <a16:creationId xmlns:a16="http://schemas.microsoft.com/office/drawing/2014/main" id="{77FA6E1F-D719-D0B9-310C-8B32411A7874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E7A9D187-A552-2952-74B3-027EFC17C51A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6731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MNN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4" name="组合 123">
              <a:extLst>
                <a:ext uri="{FF2B5EF4-FFF2-40B4-BE49-F238E27FC236}">
                  <a16:creationId xmlns:a16="http://schemas.microsoft.com/office/drawing/2014/main" id="{12462649-90FB-5ED8-B9AD-E1E548CA404B}"/>
                </a:ext>
              </a:extLst>
            </p:cNvPr>
            <p:cNvGrpSpPr/>
            <p:nvPr/>
          </p:nvGrpSpPr>
          <p:grpSpPr>
            <a:xfrm>
              <a:off x="4907280" y="2042554"/>
              <a:ext cx="815340" cy="169277"/>
              <a:chOff x="4907280" y="1553661"/>
              <a:chExt cx="815340" cy="169277"/>
            </a:xfrm>
          </p:grpSpPr>
          <p:sp>
            <p:nvSpPr>
              <p:cNvPr id="131" name="矩形 130">
                <a:extLst>
                  <a:ext uri="{FF2B5EF4-FFF2-40B4-BE49-F238E27FC236}">
                    <a16:creationId xmlns:a16="http://schemas.microsoft.com/office/drawing/2014/main" id="{F803ACF7-7484-6073-299C-914A3B5FF6DF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B9C5F1D9-0409-6832-686B-FD9ECB49C1F7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Scanorama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id="{6FB79566-B4FA-9AB9-B1A3-809A2434C438}"/>
                </a:ext>
              </a:extLst>
            </p:cNvPr>
            <p:cNvGrpSpPr/>
            <p:nvPr/>
          </p:nvGrpSpPr>
          <p:grpSpPr>
            <a:xfrm>
              <a:off x="4907280" y="2145791"/>
              <a:ext cx="815340" cy="169277"/>
              <a:chOff x="4907280" y="1553661"/>
              <a:chExt cx="815340" cy="169277"/>
            </a:xfrm>
          </p:grpSpPr>
          <p:sp>
            <p:nvSpPr>
              <p:cNvPr id="129" name="矩形 128">
                <a:extLst>
                  <a:ext uri="{FF2B5EF4-FFF2-40B4-BE49-F238E27FC236}">
                    <a16:creationId xmlns:a16="http://schemas.microsoft.com/office/drawing/2014/main" id="{F729F3BE-7729-9441-A463-E882EDD24DAE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2F1D4AFD-E0AE-BA94-A7FB-B2A00DD6A6A8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PARE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6" name="组合 125">
              <a:extLst>
                <a:ext uri="{FF2B5EF4-FFF2-40B4-BE49-F238E27FC236}">
                  <a16:creationId xmlns:a16="http://schemas.microsoft.com/office/drawing/2014/main" id="{45414DE0-C8C2-D833-F90A-EADEC91C5194}"/>
                </a:ext>
              </a:extLst>
            </p:cNvPr>
            <p:cNvGrpSpPr/>
            <p:nvPr/>
          </p:nvGrpSpPr>
          <p:grpSpPr>
            <a:xfrm>
              <a:off x="4907280" y="2244809"/>
              <a:ext cx="815340" cy="169277"/>
              <a:chOff x="4907280" y="1553661"/>
              <a:chExt cx="815340" cy="169277"/>
            </a:xfrm>
          </p:grpSpPr>
          <p:sp>
            <p:nvSpPr>
              <p:cNvPr id="127" name="矩形 126">
                <a:extLst>
                  <a:ext uri="{FF2B5EF4-FFF2-40B4-BE49-F238E27FC236}">
                    <a16:creationId xmlns:a16="http://schemas.microsoft.com/office/drawing/2014/main" id="{F9E2524E-9352-5340-1510-4AA7FF908519}"/>
                  </a:ext>
                </a:extLst>
              </p:cNvPr>
              <p:cNvSpPr/>
              <p:nvPr/>
            </p:nvSpPr>
            <p:spPr>
              <a:xfrm>
                <a:off x="4991100" y="1572260"/>
                <a:ext cx="695658" cy="1219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CA829B04-ECB7-59EB-71DC-7050906ED9B7}"/>
                  </a:ext>
                </a:extLst>
              </p:cNvPr>
              <p:cNvSpPr txBox="1"/>
              <p:nvPr/>
            </p:nvSpPr>
            <p:spPr>
              <a:xfrm>
                <a:off x="4907280" y="1553661"/>
                <a:ext cx="8153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-Harmon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9389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0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52:20Z</dcterms:created>
  <dcterms:modified xsi:type="dcterms:W3CDTF">2025-06-27T08:42:20Z</dcterms:modified>
</cp:coreProperties>
</file>